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306" r:id="rId2"/>
    <p:sldId id="311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939837-8E2E-D140-8ED2-313A7EB19DFE}" v="1" dt="2021-05-21T21:05:55.8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lie Aspden" userId="647d6aff-221e-4d07-9989-160857ddfb47" providerId="ADAL" clId="{6124FF7B-B8AD-5F41-8408-F139506A6C34}"/>
    <pc:docChg chg="delSld">
      <pc:chgData name="Julie Aspden" userId="647d6aff-221e-4d07-9989-160857ddfb47" providerId="ADAL" clId="{6124FF7B-B8AD-5F41-8408-F139506A6C34}" dt="2021-05-22T13:35:23.723" v="1" actId="2696"/>
      <pc:docMkLst>
        <pc:docMk/>
      </pc:docMkLst>
      <pc:sldChg chg="del">
        <pc:chgData name="Julie Aspden" userId="647d6aff-221e-4d07-9989-160857ddfb47" providerId="ADAL" clId="{6124FF7B-B8AD-5F41-8408-F139506A6C34}" dt="2021-05-22T13:35:22.743" v="0" actId="2696"/>
        <pc:sldMkLst>
          <pc:docMk/>
          <pc:sldMk cId="3428764821" sldId="297"/>
        </pc:sldMkLst>
      </pc:sldChg>
      <pc:sldChg chg="del">
        <pc:chgData name="Julie Aspden" userId="647d6aff-221e-4d07-9989-160857ddfb47" providerId="ADAL" clId="{6124FF7B-B8AD-5F41-8408-F139506A6C34}" dt="2021-05-22T13:35:23.723" v="1" actId="2696"/>
        <pc:sldMkLst>
          <pc:docMk/>
          <pc:sldMk cId="1983958664" sldId="3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5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AE9466AB-A76A-9748-BCD0-DD7FF55197F2}"/>
              </a:ext>
            </a:extLst>
          </p:cNvPr>
          <p:cNvSpPr txBox="1"/>
          <p:nvPr/>
        </p:nvSpPr>
        <p:spPr>
          <a:xfrm>
            <a:off x="5857153" y="205346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3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16A81E4-E7E2-4646-811A-C117B574B546}"/>
              </a:ext>
            </a:extLst>
          </p:cNvPr>
          <p:cNvGrpSpPr/>
          <p:nvPr/>
        </p:nvGrpSpPr>
        <p:grpSpPr>
          <a:xfrm>
            <a:off x="-179788" y="909699"/>
            <a:ext cx="6858000" cy="8086601"/>
            <a:chOff x="-179788" y="909699"/>
            <a:chExt cx="6858000" cy="808660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5A31844-6D88-4A8E-97AF-AC6F332B94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8992" y="909699"/>
              <a:ext cx="5949220" cy="168393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F163091-3B0A-4F54-B715-D6C80E273D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52682" y="4169707"/>
              <a:ext cx="3665913" cy="46838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FBF028D-8CB6-4FA3-867D-BF060F3B10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8884" y="5244093"/>
              <a:ext cx="5683519" cy="98209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BF2310C-FAD6-450F-8CB1-4A04B93AC23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26535" y="6792835"/>
              <a:ext cx="5683519" cy="91158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A9717C0-A1DB-42CE-B8C1-19D870075B0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28992" y="8155913"/>
              <a:ext cx="5683519" cy="708631"/>
            </a:xfrm>
            <a:prstGeom prst="rect">
              <a:avLst/>
            </a:prstGeom>
            <a:ln>
              <a:noFill/>
            </a:ln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CFA49A0-8C09-4EC4-951E-701C3E9BC7AD}"/>
                </a:ext>
              </a:extLst>
            </p:cNvPr>
            <p:cNvSpPr txBox="1"/>
            <p:nvPr/>
          </p:nvSpPr>
          <p:spPr>
            <a:xfrm rot="16200000">
              <a:off x="-176106" y="1464330"/>
              <a:ext cx="1008743" cy="574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22/</a:t>
              </a:r>
            </a:p>
            <a:p>
              <a:pPr algn="ctr"/>
              <a:r>
                <a:rPr lang="en-GB" sz="1100" b="1"/>
                <a:t>RpL22-like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12018BB-9653-4C86-A2E4-9A5229A4DB11}"/>
                </a:ext>
              </a:extLst>
            </p:cNvPr>
            <p:cNvSpPr txBox="1"/>
            <p:nvPr/>
          </p:nvSpPr>
          <p:spPr>
            <a:xfrm>
              <a:off x="-124202" y="2984999"/>
              <a:ext cx="825664" cy="5464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37a</a:t>
              </a:r>
            </a:p>
            <a:p>
              <a:pPr algn="ctr"/>
              <a:r>
                <a:rPr lang="en-GB" sz="1100" b="1"/>
                <a:t>RpL37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2A06C3F-9D13-4E1C-88E4-5393C8D7380C}"/>
                </a:ext>
              </a:extLst>
            </p:cNvPr>
            <p:cNvSpPr txBox="1"/>
            <p:nvPr/>
          </p:nvSpPr>
          <p:spPr>
            <a:xfrm>
              <a:off x="-179788" y="4103420"/>
              <a:ext cx="936836" cy="5464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S28a/</a:t>
              </a:r>
            </a:p>
            <a:p>
              <a:pPr algn="ctr"/>
              <a:r>
                <a:rPr lang="en-GB" sz="1100" b="1"/>
                <a:t>RpS28b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7F85BED-3EAD-4A86-B3F8-C6D0607CF8D7}"/>
                </a:ext>
              </a:extLst>
            </p:cNvPr>
            <p:cNvSpPr txBox="1"/>
            <p:nvPr/>
          </p:nvSpPr>
          <p:spPr>
            <a:xfrm rot="16200000">
              <a:off x="-103940" y="5420166"/>
              <a:ext cx="864404" cy="574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S19a/</a:t>
              </a:r>
            </a:p>
            <a:p>
              <a:pPr algn="ctr"/>
              <a:r>
                <a:rPr lang="en-GB" sz="1100" b="1"/>
                <a:t>RpS19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46D6755-E2A3-4A66-8220-96D67E2B6F79}"/>
                </a:ext>
              </a:extLst>
            </p:cNvPr>
            <p:cNvSpPr txBox="1"/>
            <p:nvPr/>
          </p:nvSpPr>
          <p:spPr>
            <a:xfrm rot="16200000">
              <a:off x="-103940" y="6914319"/>
              <a:ext cx="864404" cy="574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S10a/</a:t>
              </a:r>
            </a:p>
            <a:p>
              <a:pPr algn="ctr"/>
              <a:r>
                <a:rPr lang="en-GB" sz="1100" b="1"/>
                <a:t>RpS10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D76C587-9815-4562-93FA-DB4B48B53151}"/>
                </a:ext>
              </a:extLst>
            </p:cNvPr>
            <p:cNvSpPr txBox="1"/>
            <p:nvPr/>
          </p:nvSpPr>
          <p:spPr>
            <a:xfrm rot="16200000">
              <a:off x="-219786" y="8222888"/>
              <a:ext cx="972151" cy="574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S15Aa/</a:t>
              </a:r>
            </a:p>
            <a:p>
              <a:pPr algn="ctr"/>
              <a:r>
                <a:rPr lang="en-GB" sz="1100" b="1"/>
                <a:t>RpS15Ab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0723B7C-D434-4D01-85EC-225B96189E9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57048" y="2897904"/>
              <a:ext cx="5655463" cy="547091"/>
            </a:xfrm>
            <a:prstGeom prst="rect">
              <a:avLst/>
            </a:prstGeom>
          </p:spPr>
        </p:pic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E87DD273-A429-EA45-ADB0-D9726EBEE2A1}"/>
              </a:ext>
            </a:extLst>
          </p:cNvPr>
          <p:cNvSpPr/>
          <p:nvPr/>
        </p:nvSpPr>
        <p:spPr>
          <a:xfrm>
            <a:off x="63703" y="8996300"/>
            <a:ext cx="667821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 3 and 4: Unique peptide mapping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omega alignment of paralog pairs with unique peptides mapped that was detected during TMT experiments. The confidence of peptide identification is given for each unique peptide: 1 denotes high confidence (&lt;1% false discovery rate, FDR), 2 denotes medium confidence (&lt;5% FDR).</a:t>
            </a:r>
            <a:endParaRPr lang="en-GB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8776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66BA8508-9E48-0E4C-B9F2-6AD926DF1D6D}"/>
              </a:ext>
            </a:extLst>
          </p:cNvPr>
          <p:cNvGrpSpPr>
            <a:grpSpLocks noChangeAspect="1"/>
          </p:cNvGrpSpPr>
          <p:nvPr/>
        </p:nvGrpSpPr>
        <p:grpSpPr>
          <a:xfrm>
            <a:off x="117303" y="742586"/>
            <a:ext cx="6623393" cy="8420828"/>
            <a:chOff x="983853" y="741246"/>
            <a:chExt cx="4894894" cy="622325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03B04FD-4FCB-4841-92F4-0D3D46CF3C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46375" y="803969"/>
              <a:ext cx="4299985" cy="67774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CE18E51-628F-9B4C-92B3-7362FA41E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77817" y="1849108"/>
              <a:ext cx="4261475" cy="99746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EE0C7BE-C24C-5A4F-8482-05E704840A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84886" y="3302116"/>
              <a:ext cx="4261475" cy="1286826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AEE9033-2DCC-7A4E-A3D6-ED65E65F90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17272" y="5062547"/>
              <a:ext cx="4261475" cy="86150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C790A05-332B-9641-A62A-3353460EA8A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17272" y="6360734"/>
              <a:ext cx="4261468" cy="603766"/>
            </a:xfrm>
            <a:prstGeom prst="rect">
              <a:avLst/>
            </a:prstGeom>
            <a:ln>
              <a:noFill/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70A7C40-51BD-EA4A-869E-AB10CA294F46}"/>
                </a:ext>
              </a:extLst>
            </p:cNvPr>
            <p:cNvSpPr txBox="1"/>
            <p:nvPr/>
          </p:nvSpPr>
          <p:spPr>
            <a:xfrm rot="16200000">
              <a:off x="842382" y="923508"/>
              <a:ext cx="79541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24/</a:t>
              </a:r>
            </a:p>
            <a:p>
              <a:pPr algn="ctr"/>
              <a:r>
                <a:rPr lang="en-GB" sz="1100" b="1"/>
                <a:t>RpL24-lik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5AED714-D913-7A48-A957-59157AE0CA38}"/>
                </a:ext>
              </a:extLst>
            </p:cNvPr>
            <p:cNvSpPr txBox="1"/>
            <p:nvPr/>
          </p:nvSpPr>
          <p:spPr>
            <a:xfrm rot="16200000">
              <a:off x="870591" y="2132397"/>
              <a:ext cx="723276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7/</a:t>
              </a:r>
            </a:p>
            <a:p>
              <a:pPr algn="ctr"/>
              <a:r>
                <a:rPr lang="en-GB" sz="1100" b="1"/>
                <a:t>RpL7-lik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55E5EAA-0A90-6042-A755-255C6840A418}"/>
                </a:ext>
              </a:extLst>
            </p:cNvPr>
            <p:cNvSpPr txBox="1"/>
            <p:nvPr/>
          </p:nvSpPr>
          <p:spPr>
            <a:xfrm rot="16200000">
              <a:off x="872378" y="3730086"/>
              <a:ext cx="79861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P0/</a:t>
              </a:r>
            </a:p>
            <a:p>
              <a:pPr algn="ctr"/>
              <a:r>
                <a:rPr lang="en-GB" sz="1100" b="1"/>
                <a:t>RpLP0-lik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A5F7B0A-B24F-DA40-AAAC-0BA3116AAB5A}"/>
                </a:ext>
              </a:extLst>
            </p:cNvPr>
            <p:cNvSpPr txBox="1"/>
            <p:nvPr/>
          </p:nvSpPr>
          <p:spPr>
            <a:xfrm rot="16200000">
              <a:off x="894566" y="5277857"/>
              <a:ext cx="60946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S5a/</a:t>
              </a:r>
            </a:p>
            <a:p>
              <a:pPr algn="ctr"/>
              <a:r>
                <a:rPr lang="en-GB" sz="1100" b="1"/>
                <a:t>RpS5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4BAB461-FD83-B249-B0DD-33B7993C0A93}"/>
                </a:ext>
              </a:extLst>
            </p:cNvPr>
            <p:cNvSpPr txBox="1"/>
            <p:nvPr/>
          </p:nvSpPr>
          <p:spPr>
            <a:xfrm rot="16200000">
              <a:off x="895438" y="6363046"/>
              <a:ext cx="67358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b="1"/>
                <a:t>RpL34a/</a:t>
              </a:r>
            </a:p>
            <a:p>
              <a:pPr algn="ctr"/>
              <a:r>
                <a:rPr lang="en-GB" sz="1100" b="1"/>
                <a:t>RpL34b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C3D611B-94B5-0B49-98C3-9EB3C1984FFC}"/>
              </a:ext>
            </a:extLst>
          </p:cNvPr>
          <p:cNvSpPr txBox="1"/>
          <p:nvPr/>
        </p:nvSpPr>
        <p:spPr>
          <a:xfrm>
            <a:off x="5857153" y="205346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4</a:t>
            </a:r>
          </a:p>
        </p:txBody>
      </p:sp>
    </p:spTree>
    <p:extLst>
      <p:ext uri="{BB962C8B-B14F-4D97-AF65-F5344CB8AC3E}">
        <p14:creationId xmlns:p14="http://schemas.microsoft.com/office/powerpoint/2010/main" val="2358382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94</Words>
  <Application>Microsoft Macintosh PowerPoint</Application>
  <PresentationFormat>A4 Paper (210x297 mm)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3</cp:revision>
  <cp:lastPrinted>2021-04-23T12:48:59Z</cp:lastPrinted>
  <dcterms:created xsi:type="dcterms:W3CDTF">2019-05-17T07:50:07Z</dcterms:created>
  <dcterms:modified xsi:type="dcterms:W3CDTF">2021-05-22T13:35:27Z</dcterms:modified>
</cp:coreProperties>
</file>